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51"/>
    <p:restoredTop sz="94567" autoAdjust="0"/>
  </p:normalViewPr>
  <p:slideViewPr>
    <p:cSldViewPr snapToGrid="0" snapToObjects="1">
      <p:cViewPr>
        <p:scale>
          <a:sx n="150" d="100"/>
          <a:sy n="150" d="100"/>
        </p:scale>
        <p:origin x="760" y="160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ganorikamiyama:Desktop:ZIKV%20EAE%20&#35542;&#25991;:ZIKA%20EAE&#12487;&#12540;&#12479;:20200811%20DEN4%20EAE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ganorikamiyama:Desktop:ZIKV%20EAE%20&#35542;&#25991;:ZIKA%20EAE&#12487;&#12540;&#12479;:20200811%20DEN4%20EAE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74468503937008"/>
          <c:y val="0.0601851851851852"/>
          <c:w val="0.8829343832021"/>
          <c:h val="0.756798993875765"/>
        </c:manualLayout>
      </c:layout>
      <c:lineChart>
        <c:grouping val="standard"/>
        <c:varyColors val="0"/>
        <c:ser>
          <c:idx val="0"/>
          <c:order val="0"/>
          <c:tx>
            <c:strRef>
              <c:f>Sheet1!$A$45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Sheet1!$B$49:$W$49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1.405902923658554</c:v>
                  </c:pt>
                  <c:pt idx="2">
                    <c:v>0.740065257387871</c:v>
                  </c:pt>
                  <c:pt idx="3">
                    <c:v>1.836329985608917</c:v>
                  </c:pt>
                  <c:pt idx="4">
                    <c:v>2.072203619703704</c:v>
                  </c:pt>
                  <c:pt idx="5">
                    <c:v>2.085344951248536</c:v>
                  </c:pt>
                  <c:pt idx="6">
                    <c:v>3.411489445637309</c:v>
                  </c:pt>
                  <c:pt idx="7">
                    <c:v>3.28312485807922</c:v>
                  </c:pt>
                  <c:pt idx="8">
                    <c:v>3.032084007334997</c:v>
                  </c:pt>
                  <c:pt idx="9">
                    <c:v>4.08185107222204</c:v>
                  </c:pt>
                  <c:pt idx="10">
                    <c:v>3.920354601671476</c:v>
                  </c:pt>
                  <c:pt idx="11">
                    <c:v>3.476401799049277</c:v>
                  </c:pt>
                  <c:pt idx="12">
                    <c:v>4.133587906983609</c:v>
                  </c:pt>
                  <c:pt idx="13">
                    <c:v>7.916878362818296</c:v>
                  </c:pt>
                  <c:pt idx="14">
                    <c:v>9.114860211724838</c:v>
                  </c:pt>
                  <c:pt idx="15">
                    <c:v>10.98540127666864</c:v>
                  </c:pt>
                  <c:pt idx="16">
                    <c:v>10.09034031737745</c:v>
                  </c:pt>
                  <c:pt idx="17">
                    <c:v>10.71033103688178</c:v>
                  </c:pt>
                  <c:pt idx="18">
                    <c:v>11.07888571163834</c:v>
                  </c:pt>
                  <c:pt idx="19">
                    <c:v>9.990528765847417</c:v>
                  </c:pt>
                  <c:pt idx="20">
                    <c:v>9.93194226591829</c:v>
                  </c:pt>
                  <c:pt idx="21">
                    <c:v>10.55022507653803</c:v>
                  </c:pt>
                </c:numCache>
              </c:numRef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24:$W$24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45:$W$45</c:f>
              <c:numCache>
                <c:formatCode>General</c:formatCode>
                <c:ptCount val="22"/>
                <c:pt idx="0">
                  <c:v>100.0</c:v>
                </c:pt>
                <c:pt idx="1">
                  <c:v>103.313319939572</c:v>
                </c:pt>
                <c:pt idx="2">
                  <c:v>105.5119605603704</c:v>
                </c:pt>
                <c:pt idx="3">
                  <c:v>106.1892151131053</c:v>
                </c:pt>
                <c:pt idx="4">
                  <c:v>107.1837314283212</c:v>
                </c:pt>
                <c:pt idx="5">
                  <c:v>107.3187925525552</c:v>
                </c:pt>
                <c:pt idx="6">
                  <c:v>108.0340803636899</c:v>
                </c:pt>
                <c:pt idx="7">
                  <c:v>108.8870663900384</c:v>
                </c:pt>
                <c:pt idx="8">
                  <c:v>111.4429401811146</c:v>
                </c:pt>
                <c:pt idx="9">
                  <c:v>112.9141312459578</c:v>
                </c:pt>
                <c:pt idx="10">
                  <c:v>112.4371350560041</c:v>
                </c:pt>
                <c:pt idx="11">
                  <c:v>107.5519113913431</c:v>
                </c:pt>
                <c:pt idx="12">
                  <c:v>102.0561196445454</c:v>
                </c:pt>
                <c:pt idx="13">
                  <c:v>95.8872290738676</c:v>
                </c:pt>
                <c:pt idx="14">
                  <c:v>93.02209105174597</c:v>
                </c:pt>
                <c:pt idx="15">
                  <c:v>94.71290050737873</c:v>
                </c:pt>
                <c:pt idx="16">
                  <c:v>98.2150454791052</c:v>
                </c:pt>
                <c:pt idx="17">
                  <c:v>100.4840008301858</c:v>
                </c:pt>
                <c:pt idx="18">
                  <c:v>100.441964258375</c:v>
                </c:pt>
                <c:pt idx="19">
                  <c:v>103.0388601143583</c:v>
                </c:pt>
                <c:pt idx="20">
                  <c:v>104.3732342283086</c:v>
                </c:pt>
                <c:pt idx="21">
                  <c:v>106.54997376172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48D-6242-9C8F-6A722B33C3D9}"/>
            </c:ext>
          </c:extLst>
        </c:ser>
        <c:ser>
          <c:idx val="1"/>
          <c:order val="1"/>
          <c:tx>
            <c:strRef>
              <c:f>Sheet1!$A$46</c:f>
              <c:strCache>
                <c:ptCount val="1"/>
                <c:pt idx="0">
                  <c:v>DENV</c:v>
                </c:pt>
              </c:strCache>
            </c:strRef>
          </c:tx>
          <c:spPr>
            <a:ln w="15875">
              <a:solidFill>
                <a:srgbClr val="0000FF"/>
              </a:solidFill>
            </a:ln>
            <a:effectLst/>
          </c:spPr>
          <c:marker>
            <c:symbol val="circ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48:$W$48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1.984816388446468</c:v>
                  </c:pt>
                  <c:pt idx="2">
                    <c:v>1.910473141811912</c:v>
                  </c:pt>
                  <c:pt idx="3">
                    <c:v>2.935157847260855</c:v>
                  </c:pt>
                  <c:pt idx="4">
                    <c:v>2.993112423818343</c:v>
                  </c:pt>
                  <c:pt idx="5">
                    <c:v>3.173036310078785</c:v>
                  </c:pt>
                  <c:pt idx="6">
                    <c:v>3.641541206320228</c:v>
                  </c:pt>
                  <c:pt idx="7">
                    <c:v>3.876768127206577</c:v>
                  </c:pt>
                  <c:pt idx="8">
                    <c:v>4.619269930417328</c:v>
                  </c:pt>
                  <c:pt idx="9">
                    <c:v>4.827418911167819</c:v>
                  </c:pt>
                  <c:pt idx="10">
                    <c:v>6.970930979047131</c:v>
                  </c:pt>
                  <c:pt idx="11">
                    <c:v>7.918082762046247</c:v>
                  </c:pt>
                  <c:pt idx="12">
                    <c:v>9.235961620107318</c:v>
                  </c:pt>
                  <c:pt idx="13">
                    <c:v>11.62642083941354</c:v>
                  </c:pt>
                  <c:pt idx="14">
                    <c:v>11.01853758682113</c:v>
                  </c:pt>
                  <c:pt idx="15">
                    <c:v>11.12267537300224</c:v>
                  </c:pt>
                  <c:pt idx="16">
                    <c:v>10.34605933929634</c:v>
                  </c:pt>
                  <c:pt idx="17">
                    <c:v>8.43773257649763</c:v>
                  </c:pt>
                  <c:pt idx="18">
                    <c:v>7.167616515572965</c:v>
                  </c:pt>
                  <c:pt idx="19">
                    <c:v>7.989258775255311</c:v>
                  </c:pt>
                  <c:pt idx="20">
                    <c:v>8.594042104548364</c:v>
                  </c:pt>
                  <c:pt idx="21">
                    <c:v>7.6794928346396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24:$W$24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46:$W$46</c:f>
              <c:numCache>
                <c:formatCode>General</c:formatCode>
                <c:ptCount val="22"/>
                <c:pt idx="0">
                  <c:v>100.0</c:v>
                </c:pt>
                <c:pt idx="1">
                  <c:v>102.7711871888328</c:v>
                </c:pt>
                <c:pt idx="2">
                  <c:v>105.324145521265</c:v>
                </c:pt>
                <c:pt idx="3">
                  <c:v>106.6768459410075</c:v>
                </c:pt>
                <c:pt idx="4">
                  <c:v>108.7710038173118</c:v>
                </c:pt>
                <c:pt idx="5">
                  <c:v>109.3363667492413</c:v>
                </c:pt>
                <c:pt idx="6">
                  <c:v>109.4749256378688</c:v>
                </c:pt>
                <c:pt idx="7">
                  <c:v>110.019162244581</c:v>
                </c:pt>
                <c:pt idx="8">
                  <c:v>115.5732309648655</c:v>
                </c:pt>
                <c:pt idx="9">
                  <c:v>115.1737454365683</c:v>
                </c:pt>
                <c:pt idx="10">
                  <c:v>116.3352103294861</c:v>
                </c:pt>
                <c:pt idx="11">
                  <c:v>113.9646737550595</c:v>
                </c:pt>
                <c:pt idx="12">
                  <c:v>109.9401919457516</c:v>
                </c:pt>
                <c:pt idx="13">
                  <c:v>104.4675815988562</c:v>
                </c:pt>
                <c:pt idx="14">
                  <c:v>101.5203348124311</c:v>
                </c:pt>
                <c:pt idx="15">
                  <c:v>100.1007270819769</c:v>
                </c:pt>
                <c:pt idx="16">
                  <c:v>100.290556233178</c:v>
                </c:pt>
                <c:pt idx="17">
                  <c:v>100.1791256176838</c:v>
                </c:pt>
                <c:pt idx="18">
                  <c:v>100.286484924146</c:v>
                </c:pt>
                <c:pt idx="19">
                  <c:v>103.7297244982001</c:v>
                </c:pt>
                <c:pt idx="20">
                  <c:v>106.2277337487839</c:v>
                </c:pt>
                <c:pt idx="21">
                  <c:v>107.998399766152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48D-6242-9C8F-6A722B33C3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0374560"/>
        <c:axId val="2100982208"/>
      </c:lineChart>
      <c:catAx>
        <c:axId val="21003745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ja-JP"/>
          </a:p>
        </c:txPr>
        <c:crossAx val="2100982208"/>
        <c:crosses val="autoZero"/>
        <c:auto val="1"/>
        <c:lblAlgn val="ctr"/>
        <c:lblOffset val="100"/>
        <c:noMultiLvlLbl val="0"/>
      </c:catAx>
      <c:valAx>
        <c:axId val="2100982208"/>
        <c:scaling>
          <c:orientation val="minMax"/>
          <c:max val="130.0"/>
          <c:min val="85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ja-JP"/>
          </a:p>
        </c:txPr>
        <c:crossAx val="21003745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03803587051618"/>
          <c:y val="0.0601851851851852"/>
          <c:w val="0.889448381452318"/>
          <c:h val="0.756798993875765"/>
        </c:manualLayout>
      </c:layout>
      <c:lineChart>
        <c:grouping val="standard"/>
        <c:varyColors val="0"/>
        <c:ser>
          <c:idx val="0"/>
          <c:order val="0"/>
          <c:tx>
            <c:strRef>
              <c:f>Sheet1!$A$73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76:$W$76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333333333333333</c:v>
                  </c:pt>
                  <c:pt idx="11">
                    <c:v>1.05409255338946</c:v>
                  </c:pt>
                  <c:pt idx="12">
                    <c:v>0.866025403784439</c:v>
                  </c:pt>
                  <c:pt idx="13">
                    <c:v>0.927960727138337</c:v>
                  </c:pt>
                  <c:pt idx="14">
                    <c:v>0.97182531580755</c:v>
                  </c:pt>
                  <c:pt idx="15">
                    <c:v>1.130388330520878</c:v>
                  </c:pt>
                  <c:pt idx="16">
                    <c:v>1.130388330520878</c:v>
                  </c:pt>
                  <c:pt idx="17">
                    <c:v>0.707106781186548</c:v>
                  </c:pt>
                  <c:pt idx="18">
                    <c:v>0.440958551844099</c:v>
                  </c:pt>
                  <c:pt idx="19">
                    <c:v>0.440958551844099</c:v>
                  </c:pt>
                  <c:pt idx="20">
                    <c:v>0.5</c:v>
                  </c:pt>
                  <c:pt idx="21">
                    <c:v>0.527046276694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52:$W$52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73:$W$73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111111111111111</c:v>
                </c:pt>
                <c:pt idx="11">
                  <c:v>1.111111111111111</c:v>
                </c:pt>
                <c:pt idx="12">
                  <c:v>1.666666666666667</c:v>
                </c:pt>
                <c:pt idx="13">
                  <c:v>1.88888888888889</c:v>
                </c:pt>
                <c:pt idx="14">
                  <c:v>2.222222222222222</c:v>
                </c:pt>
                <c:pt idx="15">
                  <c:v>2.444444444444445</c:v>
                </c:pt>
                <c:pt idx="16">
                  <c:v>2.555555555555555</c:v>
                </c:pt>
                <c:pt idx="17">
                  <c:v>2.666666666666666</c:v>
                </c:pt>
                <c:pt idx="18">
                  <c:v>2.777777777777778</c:v>
                </c:pt>
                <c:pt idx="19">
                  <c:v>2.777777777777778</c:v>
                </c:pt>
                <c:pt idx="20">
                  <c:v>2.666666666666666</c:v>
                </c:pt>
                <c:pt idx="21">
                  <c:v>2.5555555555555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A10-9648-85A8-262E265C7D03}"/>
            </c:ext>
          </c:extLst>
        </c:ser>
        <c:ser>
          <c:idx val="1"/>
          <c:order val="1"/>
          <c:tx>
            <c:strRef>
              <c:f>Sheet1!$A$74</c:f>
              <c:strCache>
                <c:ptCount val="1"/>
                <c:pt idx="0">
                  <c:v>DENV</c:v>
                </c:pt>
              </c:strCache>
            </c:strRef>
          </c:tx>
          <c:spPr>
            <a:ln w="15875">
              <a:solidFill>
                <a:srgbClr val="0000FF"/>
              </a:solidFill>
            </a:ln>
            <a:effectLst/>
          </c:spPr>
          <c:marker>
            <c:symbol val="circ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Sheet1!$B$77:$W$77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316227766016838</c:v>
                  </c:pt>
                  <c:pt idx="11">
                    <c:v>0.948683298050514</c:v>
                  </c:pt>
                  <c:pt idx="12">
                    <c:v>1.398411797560202</c:v>
                  </c:pt>
                  <c:pt idx="13">
                    <c:v>1.316561177208767</c:v>
                  </c:pt>
                  <c:pt idx="14">
                    <c:v>1.418136492412176</c:v>
                  </c:pt>
                  <c:pt idx="15">
                    <c:v>1.316561177208767</c:v>
                  </c:pt>
                  <c:pt idx="16">
                    <c:v>0.849836585598797</c:v>
                  </c:pt>
                  <c:pt idx="17">
                    <c:v>0.699205898780101</c:v>
                  </c:pt>
                  <c:pt idx="18">
                    <c:v>0.516397779494323</c:v>
                  </c:pt>
                  <c:pt idx="19">
                    <c:v>0.516397779494323</c:v>
                  </c:pt>
                  <c:pt idx="20">
                    <c:v>0.52704627669473</c:v>
                  </c:pt>
                  <c:pt idx="21">
                    <c:v>0.516397779494322</c:v>
                  </c:pt>
                </c:numCache>
              </c:numRef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52:$W$52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74:$W$74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1</c:v>
                </c:pt>
                <c:pt idx="11">
                  <c:v>0.3</c:v>
                </c:pt>
                <c:pt idx="12">
                  <c:v>0.8</c:v>
                </c:pt>
                <c:pt idx="13">
                  <c:v>1.2</c:v>
                </c:pt>
                <c:pt idx="14">
                  <c:v>1.7</c:v>
                </c:pt>
                <c:pt idx="15">
                  <c:v>2.2</c:v>
                </c:pt>
                <c:pt idx="16">
                  <c:v>2.5</c:v>
                </c:pt>
                <c:pt idx="17">
                  <c:v>2.6</c:v>
                </c:pt>
                <c:pt idx="18">
                  <c:v>2.6</c:v>
                </c:pt>
                <c:pt idx="19">
                  <c:v>2.6</c:v>
                </c:pt>
                <c:pt idx="20">
                  <c:v>2.5</c:v>
                </c:pt>
                <c:pt idx="21">
                  <c:v>2.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A10-9648-85A8-262E265C7D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65238528"/>
        <c:axId val="-2065163536"/>
      </c:lineChart>
      <c:catAx>
        <c:axId val="-20652385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ja-JP"/>
          </a:p>
        </c:txPr>
        <c:crossAx val="-2065163536"/>
        <c:crosses val="autoZero"/>
        <c:auto val="1"/>
        <c:lblAlgn val="ctr"/>
        <c:lblOffset val="100"/>
        <c:noMultiLvlLbl val="0"/>
      </c:catAx>
      <c:valAx>
        <c:axId val="-2065163536"/>
        <c:scaling>
          <c:orientation val="minMax"/>
          <c:max val="5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ja-JP"/>
          </a:p>
        </c:txPr>
        <c:crossAx val="-20652385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グラフ 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4583927"/>
              </p:ext>
            </p:extLst>
          </p:nvPr>
        </p:nvGraphicFramePr>
        <p:xfrm>
          <a:off x="3732885" y="1096550"/>
          <a:ext cx="2758190" cy="2210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2" name="グラフ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1176633"/>
              </p:ext>
            </p:extLst>
          </p:nvPr>
        </p:nvGraphicFramePr>
        <p:xfrm>
          <a:off x="374501" y="1117572"/>
          <a:ext cx="2775661" cy="2191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67170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Fig.S4_Kamiyama et al.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502343" y="2952458"/>
            <a:ext cx="2589104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682067" y="287049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64CEF990-A5BD-1841-BC92-8E9FF5558D96}"/>
              </a:ext>
            </a:extLst>
          </p:cNvPr>
          <p:cNvSpPr txBox="1"/>
          <p:nvPr/>
        </p:nvSpPr>
        <p:spPr>
          <a:xfrm>
            <a:off x="861792" y="287049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B6F9BB82-7EF2-C24B-863C-A6CC60B52B68}"/>
              </a:ext>
            </a:extLst>
          </p:cNvPr>
          <p:cNvSpPr txBox="1"/>
          <p:nvPr/>
        </p:nvSpPr>
        <p:spPr>
          <a:xfrm>
            <a:off x="1041517" y="287049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708A8313-4EBE-A84D-8CE5-144CF9CD6118}"/>
              </a:ext>
            </a:extLst>
          </p:cNvPr>
          <p:cNvSpPr txBox="1"/>
          <p:nvPr/>
        </p:nvSpPr>
        <p:spPr>
          <a:xfrm>
            <a:off x="1221242" y="287049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1400967" y="287049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EE14A61E-8929-9048-B5CD-28FB87B52101}"/>
              </a:ext>
            </a:extLst>
          </p:cNvPr>
          <p:cNvSpPr txBox="1"/>
          <p:nvPr/>
        </p:nvSpPr>
        <p:spPr>
          <a:xfrm>
            <a:off x="1666278" y="287049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AC43DEE9-DE8D-1F42-9452-B6EC573F5AEF}"/>
              </a:ext>
            </a:extLst>
          </p:cNvPr>
          <p:cNvSpPr txBox="1"/>
          <p:nvPr/>
        </p:nvSpPr>
        <p:spPr>
          <a:xfrm>
            <a:off x="1931589" y="287049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196900" y="287049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DA6CE7E4-2C9E-4C44-9865-4688AC918023}"/>
              </a:ext>
            </a:extLst>
          </p:cNvPr>
          <p:cNvSpPr txBox="1"/>
          <p:nvPr/>
        </p:nvSpPr>
        <p:spPr>
          <a:xfrm>
            <a:off x="2462211" y="287049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C0F527A3-9827-C44F-AD18-EDB55DE1211A}"/>
              </a:ext>
            </a:extLst>
          </p:cNvPr>
          <p:cNvSpPr txBox="1"/>
          <p:nvPr/>
        </p:nvSpPr>
        <p:spPr>
          <a:xfrm>
            <a:off x="2727524" y="287049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804145" y="3063078"/>
            <a:ext cx="1963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after immunization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502342" y="28679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8" name="正方形/長方形 17"/>
          <p:cNvSpPr/>
          <p:nvPr/>
        </p:nvSpPr>
        <p:spPr>
          <a:xfrm rot="16200000">
            <a:off x="-658011" y="1798382"/>
            <a:ext cx="2031002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54579" y="276508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40372" y="245409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AC0C3899-0921-4F4C-93E7-1B96239CE567}"/>
              </a:ext>
            </a:extLst>
          </p:cNvPr>
          <p:cNvSpPr txBox="1"/>
          <p:nvPr/>
        </p:nvSpPr>
        <p:spPr>
          <a:xfrm>
            <a:off x="340372" y="210955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0E4B548D-540A-954F-AAC0-F6D6CA09E4FA}"/>
              </a:ext>
            </a:extLst>
          </p:cNvPr>
          <p:cNvSpPr txBox="1"/>
          <p:nvPr/>
        </p:nvSpPr>
        <p:spPr>
          <a:xfrm>
            <a:off x="340372" y="177307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F4C64E0E-D4C1-7F4F-9D02-BDC788DDE822}"/>
              </a:ext>
            </a:extLst>
          </p:cNvPr>
          <p:cNvSpPr txBox="1"/>
          <p:nvPr/>
        </p:nvSpPr>
        <p:spPr>
          <a:xfrm>
            <a:off x="340372" y="111844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-363278" y="1974829"/>
            <a:ext cx="1202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Clinical Score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0E4B548D-540A-954F-AAC0-F6D6CA09E4FA}"/>
              </a:ext>
            </a:extLst>
          </p:cNvPr>
          <p:cNvSpPr txBox="1"/>
          <p:nvPr/>
        </p:nvSpPr>
        <p:spPr>
          <a:xfrm>
            <a:off x="335012" y="145092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44"/>
          <p:cNvSpPr txBox="1">
            <a:spLocks noChangeArrowheads="1"/>
          </p:cNvSpPr>
          <p:nvPr/>
        </p:nvSpPr>
        <p:spPr bwMode="auto">
          <a:xfrm>
            <a:off x="58609" y="686669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28" name="テキスト ボックス 44"/>
          <p:cNvSpPr txBox="1">
            <a:spLocks noChangeArrowheads="1"/>
          </p:cNvSpPr>
          <p:nvPr/>
        </p:nvSpPr>
        <p:spPr bwMode="auto">
          <a:xfrm>
            <a:off x="3486101" y="686669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/>
                <a:cs typeface="Helvetica"/>
              </a:rPr>
              <a:t>B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3876052" y="2932031"/>
            <a:ext cx="2623109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4089781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64CEF990-A5BD-1841-BC92-8E9FF5558D96}"/>
              </a:ext>
            </a:extLst>
          </p:cNvPr>
          <p:cNvSpPr txBox="1"/>
          <p:nvPr/>
        </p:nvSpPr>
        <p:spPr>
          <a:xfrm>
            <a:off x="4269506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B6F9BB82-7EF2-C24B-863C-A6CC60B52B68}"/>
              </a:ext>
            </a:extLst>
          </p:cNvPr>
          <p:cNvSpPr txBox="1"/>
          <p:nvPr/>
        </p:nvSpPr>
        <p:spPr>
          <a:xfrm>
            <a:off x="4449231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708A8313-4EBE-A84D-8CE5-144CF9CD6118}"/>
              </a:ext>
            </a:extLst>
          </p:cNvPr>
          <p:cNvSpPr txBox="1"/>
          <p:nvPr/>
        </p:nvSpPr>
        <p:spPr>
          <a:xfrm>
            <a:off x="4628956" y="287146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808681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EE14A61E-8929-9048-B5CD-28FB87B52101}"/>
              </a:ext>
            </a:extLst>
          </p:cNvPr>
          <p:cNvSpPr txBox="1"/>
          <p:nvPr/>
        </p:nvSpPr>
        <p:spPr>
          <a:xfrm>
            <a:off x="5073992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AC43DEE9-DE8D-1F42-9452-B6EC573F5AEF}"/>
              </a:ext>
            </a:extLst>
          </p:cNvPr>
          <p:cNvSpPr txBox="1"/>
          <p:nvPr/>
        </p:nvSpPr>
        <p:spPr>
          <a:xfrm>
            <a:off x="5339303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604614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DA6CE7E4-2C9E-4C44-9865-4688AC918023}"/>
              </a:ext>
            </a:extLst>
          </p:cNvPr>
          <p:cNvSpPr txBox="1"/>
          <p:nvPr/>
        </p:nvSpPr>
        <p:spPr>
          <a:xfrm>
            <a:off x="5869925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C0F527A3-9827-C44F-AD18-EDB55DE1211A}"/>
              </a:ext>
            </a:extLst>
          </p:cNvPr>
          <p:cNvSpPr txBox="1"/>
          <p:nvPr/>
        </p:nvSpPr>
        <p:spPr>
          <a:xfrm>
            <a:off x="6135238" y="287146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211859" y="3064056"/>
            <a:ext cx="1963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after immunization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79394661-8AAD-894B-B321-DF2F09BB1A34}"/>
              </a:ext>
            </a:extLst>
          </p:cNvPr>
          <p:cNvSpPr txBox="1"/>
          <p:nvPr/>
        </p:nvSpPr>
        <p:spPr>
          <a:xfrm>
            <a:off x="3910056" y="286892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4" name="正方形/長方形 43"/>
          <p:cNvSpPr/>
          <p:nvPr/>
        </p:nvSpPr>
        <p:spPr>
          <a:xfrm rot="5400000">
            <a:off x="2787442" y="1910479"/>
            <a:ext cx="1953759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665041" y="2578043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9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 rot="16200000">
            <a:off x="2707526" y="1893404"/>
            <a:ext cx="1638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% of original weight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86646" y="2193379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98406" y="1814062"/>
            <a:ext cx="433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95540" y="1447687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877807" y="1488439"/>
            <a:ext cx="5052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AE</a:t>
            </a:r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885441" y="1770981"/>
            <a:ext cx="110799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ja-JP" altLang="ja-JP" sz="1200" b="1" dirty="0">
                <a:latin typeface="Helvetica"/>
                <a:ea typeface="Helvetica" charset="0"/>
                <a:cs typeface="Helvetica"/>
              </a:rPr>
              <a:t>D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NV</a:t>
            </a:r>
            <a:r>
              <a:rPr lang="ja-JP" altLang="ja-JP" sz="12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+ EAE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EF05A6EE-448A-1840-A05D-D94077708515}"/>
              </a:ext>
            </a:extLst>
          </p:cNvPr>
          <p:cNvSpPr txBox="1"/>
          <p:nvPr/>
        </p:nvSpPr>
        <p:spPr>
          <a:xfrm>
            <a:off x="3591189" y="1085685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3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4261872" y="2321628"/>
            <a:ext cx="5052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AE</a:t>
            </a:r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4269506" y="2604170"/>
            <a:ext cx="110799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ja-JP" altLang="ja-JP" sz="1200" b="1" dirty="0">
                <a:latin typeface="Helvetica"/>
                <a:ea typeface="Helvetica" charset="0"/>
                <a:cs typeface="Helvetica"/>
              </a:rPr>
              <a:t>D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NV</a:t>
            </a:r>
            <a:r>
              <a:rPr lang="ja-JP" altLang="ja-JP" sz="12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+ EAE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1" name="二等辺三角形 60"/>
          <p:cNvSpPr/>
          <p:nvPr/>
        </p:nvSpPr>
        <p:spPr>
          <a:xfrm>
            <a:off x="810131" y="1613993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62" name="円/楕円 61"/>
          <p:cNvSpPr/>
          <p:nvPr/>
        </p:nvSpPr>
        <p:spPr>
          <a:xfrm>
            <a:off x="802692" y="1880971"/>
            <a:ext cx="64355" cy="64349"/>
          </a:xfrm>
          <a:prstGeom prst="ellipse">
            <a:avLst/>
          </a:prstGeom>
          <a:solidFill>
            <a:srgbClr val="0000FF"/>
          </a:solidFill>
          <a:ln w="285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63" name="二等辺三角形 62"/>
          <p:cNvSpPr/>
          <p:nvPr/>
        </p:nvSpPr>
        <p:spPr>
          <a:xfrm>
            <a:off x="4194233" y="2458488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64" name="円/楕円 63"/>
          <p:cNvSpPr/>
          <p:nvPr/>
        </p:nvSpPr>
        <p:spPr>
          <a:xfrm>
            <a:off x="4186794" y="2725466"/>
            <a:ext cx="64355" cy="64349"/>
          </a:xfrm>
          <a:prstGeom prst="ellipse">
            <a:avLst/>
          </a:prstGeom>
          <a:solidFill>
            <a:srgbClr val="0000FF"/>
          </a:solidFill>
          <a:ln w="285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69471456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7</TotalTime>
  <Words>61</Words>
  <Application>Microsoft Macintosh PowerPoint</Application>
  <PresentationFormat>画面に合わせる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Calibri</vt:lpstr>
      <vt:lpstr>Helvetica</vt:lpstr>
      <vt:lpstr>ＭＳ Ｐゴシック</vt:lpstr>
      <vt:lpstr>Arial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神山長慶</cp:lastModifiedBy>
  <cp:revision>329</cp:revision>
  <cp:lastPrinted>2024-05-22T05:30:17Z</cp:lastPrinted>
  <dcterms:created xsi:type="dcterms:W3CDTF">2022-03-10T04:52:23Z</dcterms:created>
  <dcterms:modified xsi:type="dcterms:W3CDTF">2025-05-01T06:26:40Z</dcterms:modified>
  <cp:category/>
</cp:coreProperties>
</file>